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336" r:id="rId2"/>
    <p:sldId id="337" r:id="rId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9967" autoAdjust="0"/>
    <p:restoredTop sz="94660"/>
  </p:normalViewPr>
  <p:slideViewPr>
    <p:cSldViewPr snapToGrid="0">
      <p:cViewPr varScale="1">
        <p:scale>
          <a:sx n="97" d="100"/>
          <a:sy n="97" d="100"/>
        </p:scale>
        <p:origin x="96" y="18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430F53-4FD1-4C5F-A2E3-A298EFF3ED91}" type="datetimeFigureOut">
              <a:rPr kumimoji="1" lang="ja-JP" altLang="en-US" smtClean="0"/>
              <a:t>2024/9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B48F7-4F34-46AE-85D8-DC01021C25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559349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430F53-4FD1-4C5F-A2E3-A298EFF3ED91}" type="datetimeFigureOut">
              <a:rPr kumimoji="1" lang="ja-JP" altLang="en-US" smtClean="0"/>
              <a:t>2024/9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B48F7-4F34-46AE-85D8-DC01021C25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00190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430F53-4FD1-4C5F-A2E3-A298EFF3ED91}" type="datetimeFigureOut">
              <a:rPr kumimoji="1" lang="ja-JP" altLang="en-US" smtClean="0"/>
              <a:t>2024/9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B48F7-4F34-46AE-85D8-DC01021C25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676754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430F53-4FD1-4C5F-A2E3-A298EFF3ED91}" type="datetimeFigureOut">
              <a:rPr kumimoji="1" lang="ja-JP" altLang="en-US" smtClean="0"/>
              <a:t>2024/9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B48F7-4F34-46AE-85D8-DC01021C25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339304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430F53-4FD1-4C5F-A2E3-A298EFF3ED91}" type="datetimeFigureOut">
              <a:rPr kumimoji="1" lang="ja-JP" altLang="en-US" smtClean="0"/>
              <a:t>2024/9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B48F7-4F34-46AE-85D8-DC01021C25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078931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430F53-4FD1-4C5F-A2E3-A298EFF3ED91}" type="datetimeFigureOut">
              <a:rPr kumimoji="1" lang="ja-JP" altLang="en-US" smtClean="0"/>
              <a:t>2024/9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B48F7-4F34-46AE-85D8-DC01021C25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742326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430F53-4FD1-4C5F-A2E3-A298EFF3ED91}" type="datetimeFigureOut">
              <a:rPr kumimoji="1" lang="ja-JP" altLang="en-US" smtClean="0"/>
              <a:t>2024/9/2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B48F7-4F34-46AE-85D8-DC01021C25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845196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430F53-4FD1-4C5F-A2E3-A298EFF3ED91}" type="datetimeFigureOut">
              <a:rPr kumimoji="1" lang="ja-JP" altLang="en-US" smtClean="0"/>
              <a:t>2024/9/2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B48F7-4F34-46AE-85D8-DC01021C25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462896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430F53-4FD1-4C5F-A2E3-A298EFF3ED91}" type="datetimeFigureOut">
              <a:rPr kumimoji="1" lang="ja-JP" altLang="en-US" smtClean="0"/>
              <a:t>2024/9/2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B48F7-4F34-46AE-85D8-DC01021C25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0048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430F53-4FD1-4C5F-A2E3-A298EFF3ED91}" type="datetimeFigureOut">
              <a:rPr kumimoji="1" lang="ja-JP" altLang="en-US" smtClean="0"/>
              <a:t>2024/9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B48F7-4F34-46AE-85D8-DC01021C25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26386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430F53-4FD1-4C5F-A2E3-A298EFF3ED91}" type="datetimeFigureOut">
              <a:rPr kumimoji="1" lang="ja-JP" altLang="en-US" smtClean="0"/>
              <a:t>2024/9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B48F7-4F34-46AE-85D8-DC01021C25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028333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430F53-4FD1-4C5F-A2E3-A298EFF3ED91}" type="datetimeFigureOut">
              <a:rPr kumimoji="1" lang="ja-JP" altLang="en-US" smtClean="0"/>
              <a:t>2024/9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5B48F7-4F34-46AE-85D8-DC01021C25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306147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表 2">
            <a:extLst>
              <a:ext uri="{FF2B5EF4-FFF2-40B4-BE49-F238E27FC236}">
                <a16:creationId xmlns:a16="http://schemas.microsoft.com/office/drawing/2014/main" id="{C7BCC02E-8C8F-3E5D-7375-D3743C2A8C70}"/>
              </a:ext>
            </a:extLst>
          </p:cNvPr>
          <p:cNvGraphicFramePr>
            <a:graphicFrameLocks noGrp="1"/>
          </p:cNvGraphicFramePr>
          <p:nvPr/>
        </p:nvGraphicFramePr>
        <p:xfrm>
          <a:off x="628650" y="1275595"/>
          <a:ext cx="7886700" cy="3032937"/>
        </p:xfrm>
        <a:graphic>
          <a:graphicData uri="http://schemas.openxmlformats.org/drawingml/2006/table">
            <a:tbl>
              <a:tblPr/>
              <a:tblGrid>
                <a:gridCol w="571270">
                  <a:extLst>
                    <a:ext uri="{9D8B030D-6E8A-4147-A177-3AD203B41FA5}">
                      <a16:colId xmlns:a16="http://schemas.microsoft.com/office/drawing/2014/main" val="978705014"/>
                    </a:ext>
                  </a:extLst>
                </a:gridCol>
                <a:gridCol w="867005">
                  <a:extLst>
                    <a:ext uri="{9D8B030D-6E8A-4147-A177-3AD203B41FA5}">
                      <a16:colId xmlns:a16="http://schemas.microsoft.com/office/drawing/2014/main" val="1685484691"/>
                    </a:ext>
                  </a:extLst>
                </a:gridCol>
                <a:gridCol w="2386061">
                  <a:extLst>
                    <a:ext uri="{9D8B030D-6E8A-4147-A177-3AD203B41FA5}">
                      <a16:colId xmlns:a16="http://schemas.microsoft.com/office/drawing/2014/main" val="1762552730"/>
                    </a:ext>
                  </a:extLst>
                </a:gridCol>
                <a:gridCol w="571270">
                  <a:extLst>
                    <a:ext uri="{9D8B030D-6E8A-4147-A177-3AD203B41FA5}">
                      <a16:colId xmlns:a16="http://schemas.microsoft.com/office/drawing/2014/main" val="2307132302"/>
                    </a:ext>
                  </a:extLst>
                </a:gridCol>
                <a:gridCol w="571270">
                  <a:extLst>
                    <a:ext uri="{9D8B030D-6E8A-4147-A177-3AD203B41FA5}">
                      <a16:colId xmlns:a16="http://schemas.microsoft.com/office/drawing/2014/main" val="3449148051"/>
                    </a:ext>
                  </a:extLst>
                </a:gridCol>
                <a:gridCol w="571270">
                  <a:extLst>
                    <a:ext uri="{9D8B030D-6E8A-4147-A177-3AD203B41FA5}">
                      <a16:colId xmlns:a16="http://schemas.microsoft.com/office/drawing/2014/main" val="3371722258"/>
                    </a:ext>
                  </a:extLst>
                </a:gridCol>
                <a:gridCol w="571270">
                  <a:extLst>
                    <a:ext uri="{9D8B030D-6E8A-4147-A177-3AD203B41FA5}">
                      <a16:colId xmlns:a16="http://schemas.microsoft.com/office/drawing/2014/main" val="4159772128"/>
                    </a:ext>
                  </a:extLst>
                </a:gridCol>
                <a:gridCol w="1206014">
                  <a:extLst>
                    <a:ext uri="{9D8B030D-6E8A-4147-A177-3AD203B41FA5}">
                      <a16:colId xmlns:a16="http://schemas.microsoft.com/office/drawing/2014/main" val="2985386815"/>
                    </a:ext>
                  </a:extLst>
                </a:gridCol>
                <a:gridCol w="571270">
                  <a:extLst>
                    <a:ext uri="{9D8B030D-6E8A-4147-A177-3AD203B41FA5}">
                      <a16:colId xmlns:a16="http://schemas.microsoft.com/office/drawing/2014/main" val="2910412419"/>
                    </a:ext>
                  </a:extLst>
                </a:gridCol>
              </a:tblGrid>
              <a:tr h="389042">
                <a:tc gridSpan="3">
                  <a:txBody>
                    <a:bodyPr/>
                    <a:lstStyle/>
                    <a:p>
                      <a:pPr algn="l" fontAlgn="ctr"/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940" marR="7940" marT="79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940" marR="7940" marT="79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940" marR="7940" marT="79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940" marR="7940" marT="79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940" marR="7940" marT="79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940" marR="7940" marT="79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940" marR="7940" marT="79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80091500"/>
                  </a:ext>
                </a:extLst>
              </a:tr>
              <a:tr h="4208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FW or RV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Name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Sequence(5'- 3')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base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Tm1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Tm2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uM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Location               (BKV Gardner St.)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17352868"/>
                  </a:ext>
                </a:extLst>
              </a:tr>
              <a:tr h="317585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　</a:t>
                      </a:r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FW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308523_01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ACTCTTCTGTTCCATAGGTTG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21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54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50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50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4579 - 4599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58449034"/>
                  </a:ext>
                </a:extLst>
              </a:tr>
              <a:tr h="317585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　</a:t>
                      </a:r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RV</a:t>
                      </a:r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308523_02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CCTTGCCTGCTTTGCTGTG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9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57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55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50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4375 - 4357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4443330"/>
                  </a:ext>
                </a:extLst>
              </a:tr>
              <a:tr h="317585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　</a:t>
                      </a:r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FW</a:t>
                      </a:r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308523_03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CCTCCACACCCTTACTACTT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20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55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50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50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64 - 83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34267899"/>
                  </a:ext>
                </a:extLst>
              </a:tr>
              <a:tr h="317585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　</a:t>
                      </a:r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RV</a:t>
                      </a:r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308523_04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CAAGCAGTAGATACAGTTTTAG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22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52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50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50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3825 - 3804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16051341"/>
                  </a:ext>
                </a:extLst>
              </a:tr>
              <a:tr h="317585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　</a:t>
                      </a:r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FW</a:t>
                      </a:r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308523_05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TGCTGGAATTTTGTAGAGGTGA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22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54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53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50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531 -552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96268577"/>
                  </a:ext>
                </a:extLst>
              </a:tr>
              <a:tr h="317585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　</a:t>
                      </a:r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FW</a:t>
                      </a:r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308523_07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GTCCCAGGTAATGAATACTGA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21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54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49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50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2158 - 2178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48105141"/>
                  </a:ext>
                </a:extLst>
              </a:tr>
              <a:tr h="317585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　</a:t>
                      </a:r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FW</a:t>
                      </a:r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308523_08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AAACAGGTGCTTTTATTGTACAT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23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51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50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50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2688 - 2710</a:t>
                      </a: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940" marR="7940" marT="794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16916981"/>
                  </a:ext>
                </a:extLst>
              </a:tr>
            </a:tbl>
          </a:graphicData>
        </a:graphic>
      </p:graphicFrame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EFDAA62A-315E-F340-FD96-0CE53E188A3B}"/>
              </a:ext>
            </a:extLst>
          </p:cNvPr>
          <p:cNvSpPr txBox="1"/>
          <p:nvPr/>
        </p:nvSpPr>
        <p:spPr>
          <a:xfrm>
            <a:off x="333375" y="723900"/>
            <a:ext cx="202331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Data 1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11AAD858-9E88-8017-19C2-28B1177BB2BA}"/>
              </a:ext>
            </a:extLst>
          </p:cNvPr>
          <p:cNvSpPr txBox="1"/>
          <p:nvPr/>
        </p:nvSpPr>
        <p:spPr>
          <a:xfrm>
            <a:off x="2453047" y="734206"/>
            <a:ext cx="286007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imers used for</a:t>
            </a:r>
            <a:r>
              <a:rPr kumimoji="1"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imer</a:t>
            </a:r>
            <a:r>
              <a:rPr kumimoji="1"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alking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7803800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4FFD0C4D-BFF7-F94A-AFF6-6CA5332A3DC6}"/>
              </a:ext>
            </a:extLst>
          </p:cNvPr>
          <p:cNvSpPr txBox="1"/>
          <p:nvPr/>
        </p:nvSpPr>
        <p:spPr>
          <a:xfrm>
            <a:off x="504825" y="219075"/>
            <a:ext cx="207460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Data  2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3" name="表 2">
            <a:extLst>
              <a:ext uri="{FF2B5EF4-FFF2-40B4-BE49-F238E27FC236}">
                <a16:creationId xmlns:a16="http://schemas.microsoft.com/office/drawing/2014/main" id="{5E65288A-747D-5EEE-7804-C4D504641667}"/>
              </a:ext>
            </a:extLst>
          </p:cNvPr>
          <p:cNvGraphicFramePr>
            <a:graphicFrameLocks noGrp="1"/>
          </p:cNvGraphicFramePr>
          <p:nvPr/>
        </p:nvGraphicFramePr>
        <p:xfrm>
          <a:off x="1247776" y="1028700"/>
          <a:ext cx="5505450" cy="5143497"/>
        </p:xfrm>
        <a:graphic>
          <a:graphicData uri="http://schemas.openxmlformats.org/drawingml/2006/table">
            <a:tbl>
              <a:tblPr/>
              <a:tblGrid>
                <a:gridCol w="944806">
                  <a:extLst>
                    <a:ext uri="{9D8B030D-6E8A-4147-A177-3AD203B41FA5}">
                      <a16:colId xmlns:a16="http://schemas.microsoft.com/office/drawing/2014/main" val="2918548075"/>
                    </a:ext>
                  </a:extLst>
                </a:gridCol>
                <a:gridCol w="511474">
                  <a:extLst>
                    <a:ext uri="{9D8B030D-6E8A-4147-A177-3AD203B41FA5}">
                      <a16:colId xmlns:a16="http://schemas.microsoft.com/office/drawing/2014/main" val="4293223756"/>
                    </a:ext>
                  </a:extLst>
                </a:gridCol>
                <a:gridCol w="646446">
                  <a:extLst>
                    <a:ext uri="{9D8B030D-6E8A-4147-A177-3AD203B41FA5}">
                      <a16:colId xmlns:a16="http://schemas.microsoft.com/office/drawing/2014/main" val="3265300266"/>
                    </a:ext>
                  </a:extLst>
                </a:gridCol>
                <a:gridCol w="909287">
                  <a:extLst>
                    <a:ext uri="{9D8B030D-6E8A-4147-A177-3AD203B41FA5}">
                      <a16:colId xmlns:a16="http://schemas.microsoft.com/office/drawing/2014/main" val="2226096994"/>
                    </a:ext>
                  </a:extLst>
                </a:gridCol>
                <a:gridCol w="447541">
                  <a:extLst>
                    <a:ext uri="{9D8B030D-6E8A-4147-A177-3AD203B41FA5}">
                      <a16:colId xmlns:a16="http://schemas.microsoft.com/office/drawing/2014/main" val="384704112"/>
                    </a:ext>
                  </a:extLst>
                </a:gridCol>
                <a:gridCol w="2045896">
                  <a:extLst>
                    <a:ext uri="{9D8B030D-6E8A-4147-A177-3AD203B41FA5}">
                      <a16:colId xmlns:a16="http://schemas.microsoft.com/office/drawing/2014/main" val="1797111779"/>
                    </a:ext>
                  </a:extLst>
                </a:gridCol>
              </a:tblGrid>
              <a:tr h="646269">
                <a:tc gridSpan="6"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track name=IAD178171_Designed description=Covered_bases solution_type=182 AmpliSeq_Version=7.06 workflow=dna ionVersion=4.0 db=BKV reference=BKV type=bedDetail color=77,175,74 priority=2.0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30457596"/>
                  </a:ext>
                </a:extLst>
              </a:tr>
              <a:tr h="1665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LC2019_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3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48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MPL3592014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.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ool=1;SUBMITTED_REGION=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4408795"/>
                  </a:ext>
                </a:extLst>
              </a:tr>
              <a:tr h="1665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LC2019_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72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02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MPL3592015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.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ool=2;SUBMITTED_REGION=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81305679"/>
                  </a:ext>
                </a:extLst>
              </a:tr>
              <a:tr h="1665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LC2019_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91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601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MPL3592016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.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ool=1;SUBMITTED_REGION=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76185844"/>
                  </a:ext>
                </a:extLst>
              </a:tr>
              <a:tr h="1665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LC2019_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590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810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MPL3592017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.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ool=2;SUBMITTED_REGION=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38822288"/>
                  </a:ext>
                </a:extLst>
              </a:tr>
              <a:tr h="1665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LC2019_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799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017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MPL3592018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.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ool=1;SUBMITTED_REGION=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17105483"/>
                  </a:ext>
                </a:extLst>
              </a:tr>
              <a:tr h="1665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LC2019_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006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222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MPL3592019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.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ool=2;SUBMITTED_REGION=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20704657"/>
                  </a:ext>
                </a:extLst>
              </a:tr>
              <a:tr h="1665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LC2019_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211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408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MPL3592020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.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ool=1;SUBMITTED_REGION=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30294530"/>
                  </a:ext>
                </a:extLst>
              </a:tr>
              <a:tr h="1665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LC2019_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397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612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MPL3592021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.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ool=2;SUBMITTED_REGION=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73322789"/>
                  </a:ext>
                </a:extLst>
              </a:tr>
              <a:tr h="1665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LC2019_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601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827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MPL3592022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.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ool=1;SUBMITTED_REGION=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41083347"/>
                  </a:ext>
                </a:extLst>
              </a:tr>
              <a:tr h="1665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LC2019_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816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996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MPL3592023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.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ool=2;SUBMITTED_REGION=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99307413"/>
                  </a:ext>
                </a:extLst>
              </a:tr>
              <a:tr h="1665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LC2019_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985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186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MPL3592024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.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ool=1;SUBMITTED_REGION=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58523231"/>
                  </a:ext>
                </a:extLst>
              </a:tr>
              <a:tr h="1665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LC2019_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175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390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MPL3592025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.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ool=2;SUBMITTED_REGION=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50805186"/>
                  </a:ext>
                </a:extLst>
              </a:tr>
              <a:tr h="1665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LC2019_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379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584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MPL3592026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.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ool=1;SUBMITTED_REGION=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24196674"/>
                  </a:ext>
                </a:extLst>
              </a:tr>
              <a:tr h="1665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LC2019_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573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779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MPL3592027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.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ool=2;SUBMITTED_REGION=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24945950"/>
                  </a:ext>
                </a:extLst>
              </a:tr>
              <a:tr h="1665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LC2019_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768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864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MPL3592028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.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ool=1;SUBMITTED_REGION=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41179490"/>
                  </a:ext>
                </a:extLst>
              </a:tr>
              <a:tr h="1665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LC2019_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853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060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MPL3592029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.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ool=2;SUBMITTED_REGION=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93706909"/>
                  </a:ext>
                </a:extLst>
              </a:tr>
              <a:tr h="1665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LC2019_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049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254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MPL3592030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.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ool=1;SUBMITTED_REGION=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7486028"/>
                  </a:ext>
                </a:extLst>
              </a:tr>
              <a:tr h="1665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LC2019_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243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469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MPL3592031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.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ool=2;SUBMITTED_REGION=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96662427"/>
                  </a:ext>
                </a:extLst>
              </a:tr>
              <a:tr h="1665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LC2019_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458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672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MPL3592032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.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ool=1;SUBMITTED_REGION=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34858051"/>
                  </a:ext>
                </a:extLst>
              </a:tr>
              <a:tr h="1665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LC2019_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660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853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MPL3592033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.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ool=2;SUBMITTED_REGION=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65008385"/>
                  </a:ext>
                </a:extLst>
              </a:tr>
              <a:tr h="1665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LC2019_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841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018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MPL3592034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.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ool=1;SUBMITTED_REGION=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17331484"/>
                  </a:ext>
                </a:extLst>
              </a:tr>
              <a:tr h="1665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LC2019_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007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218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MPL3592035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.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ool=2;SUBMITTED_REGION=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44800562"/>
                  </a:ext>
                </a:extLst>
              </a:tr>
              <a:tr h="1665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LC2019_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207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394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MPL3592036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.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ool=1;SUBMITTED_REGION=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28804297"/>
                  </a:ext>
                </a:extLst>
              </a:tr>
              <a:tr h="1665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LC2019_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383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516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MPL3592037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.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ool=2;SUBMITTED_REGION=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87485189"/>
                  </a:ext>
                </a:extLst>
              </a:tr>
              <a:tr h="1665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LC2019_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505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718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MPL3592038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.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ool=1;SUBMITTED_REGION=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15551556"/>
                  </a:ext>
                </a:extLst>
              </a:tr>
              <a:tr h="1665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LC2019_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707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923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MPL3592039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.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ool=2;SUBMITTED_REGION=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62567990"/>
                  </a:ext>
                </a:extLst>
              </a:tr>
              <a:tr h="1665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LC2019_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912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5139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MPL3592040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.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ool=1;SUBMITTED_REGION=BKV</a:t>
                      </a:r>
                    </a:p>
                  </a:txBody>
                  <a:tcPr marL="5636" marR="5636" marT="56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77122170"/>
                  </a:ext>
                </a:extLst>
              </a:tr>
            </a:tbl>
          </a:graphicData>
        </a:graphic>
      </p:graphicFrame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96C0CBC4-F357-83F3-07AA-7237EA09CFCF}"/>
              </a:ext>
            </a:extLst>
          </p:cNvPr>
          <p:cNvSpPr txBox="1"/>
          <p:nvPr/>
        </p:nvSpPr>
        <p:spPr>
          <a:xfrm>
            <a:off x="2596556" y="209550"/>
            <a:ext cx="57743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mplicon location of NGS sequencing on the reference sequences 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971035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4</TotalTime>
  <Words>591</Words>
  <Application>Microsoft Office PowerPoint</Application>
  <PresentationFormat>画面に合わせる (4:3)</PresentationFormat>
  <Paragraphs>231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hioda</dc:creator>
  <cp:lastModifiedBy>Shioda</cp:lastModifiedBy>
  <cp:revision>1</cp:revision>
  <dcterms:created xsi:type="dcterms:W3CDTF">2024-09-20T05:47:23Z</dcterms:created>
  <dcterms:modified xsi:type="dcterms:W3CDTF">2024-09-20T05:51:34Z</dcterms:modified>
</cp:coreProperties>
</file>